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Stile medio 2 - Colore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1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866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5945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1127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5599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4426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9504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1328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8418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9750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9170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7461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62A27E-D25F-49A1-8129-C95E9DC5FE54}" type="datetimeFigureOut">
              <a:rPr lang="it-IT" smtClean="0"/>
              <a:t>11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75CD6-B469-4129-8550-7258E50F6D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79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9352506"/>
              </p:ext>
            </p:extLst>
          </p:nvPr>
        </p:nvGraphicFramePr>
        <p:xfrm>
          <a:off x="151001" y="272876"/>
          <a:ext cx="8875553" cy="5633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99627"/>
                <a:gridCol w="2235296"/>
                <a:gridCol w="2963522"/>
                <a:gridCol w="2477108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300" b="1" dirty="0" err="1" smtClean="0"/>
                        <a:t>MoW</a:t>
                      </a:r>
                      <a:r>
                        <a:rPr lang="it-IT" sz="1300" b="1" dirty="0" smtClean="0"/>
                        <a:t> </a:t>
                      </a:r>
                      <a:r>
                        <a:rPr lang="it-IT" sz="1300" b="1" dirty="0" err="1" smtClean="0"/>
                        <a:t>number</a:t>
                      </a:r>
                      <a:endParaRPr lang="it-IT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300" b="1" dirty="0" err="1" smtClean="0"/>
                        <a:t>MoW</a:t>
                      </a:r>
                      <a:r>
                        <a:rPr lang="it-IT" sz="1300" b="1" dirty="0" smtClean="0"/>
                        <a:t> ID</a:t>
                      </a:r>
                      <a:endParaRPr lang="it-IT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300" b="1" dirty="0" err="1" smtClean="0"/>
                        <a:t>Main</a:t>
                      </a:r>
                      <a:r>
                        <a:rPr lang="it-IT" sz="1300" b="1" dirty="0" smtClean="0"/>
                        <a:t> </a:t>
                      </a:r>
                      <a:r>
                        <a:rPr lang="it-IT" sz="1300" b="1" dirty="0" err="1" smtClean="0"/>
                        <a:t>components</a:t>
                      </a:r>
                      <a:endParaRPr lang="it-IT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b="1" dirty="0" err="1" smtClean="0"/>
                        <a:t>Other</a:t>
                      </a:r>
                      <a:r>
                        <a:rPr lang="it-IT" sz="1200" b="1" dirty="0" smtClean="0"/>
                        <a:t> </a:t>
                      </a:r>
                      <a:r>
                        <a:rPr lang="it-IT" sz="1200" b="1" dirty="0" err="1" smtClean="0"/>
                        <a:t>components</a:t>
                      </a:r>
                      <a:endParaRPr lang="it-IT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1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Curasept</a:t>
                      </a:r>
                      <a:r>
                        <a:rPr lang="it-IT" sz="1300" dirty="0" smtClean="0"/>
                        <a:t> 0.20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smtClean="0"/>
                        <a:t>0.2% </a:t>
                      </a:r>
                      <a:r>
                        <a:rPr lang="it-IT" sz="1300" dirty="0" err="1" smtClean="0"/>
                        <a:t>Chlorhexidine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Digluconate</a:t>
                      </a:r>
                      <a:endParaRPr lang="it-IT" sz="1300" dirty="0" smtClean="0"/>
                    </a:p>
                    <a:p>
                      <a:r>
                        <a:rPr lang="it-IT" sz="1300" dirty="0" smtClean="0"/>
                        <a:t>Anti</a:t>
                      </a:r>
                      <a:r>
                        <a:rPr lang="it-IT" sz="1300" baseline="0" dirty="0" smtClean="0"/>
                        <a:t> </a:t>
                      </a:r>
                      <a:r>
                        <a:rPr lang="it-IT" sz="1300" baseline="0" dirty="0" err="1" smtClean="0"/>
                        <a:t>Discoloration</a:t>
                      </a:r>
                      <a:r>
                        <a:rPr lang="it-IT" sz="1300" baseline="0" dirty="0" smtClean="0"/>
                        <a:t> System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Xyl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ene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Glycol</a:t>
                      </a:r>
                      <a:r>
                        <a:rPr lang="it-IT" sz="900" dirty="0" smtClean="0"/>
                        <a:t>, PEG-40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Hydrogenated</a:t>
                      </a:r>
                      <a:r>
                        <a:rPr lang="it-IT" sz="900" baseline="0" dirty="0" smtClean="0"/>
                        <a:t> Castor </a:t>
                      </a:r>
                      <a:r>
                        <a:rPr lang="it-IT" sz="900" baseline="0" dirty="0" err="1" smtClean="0"/>
                        <a:t>Oil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Ascorbic</a:t>
                      </a:r>
                      <a:r>
                        <a:rPr lang="it-IT" sz="900" baseline="0" dirty="0" smtClean="0"/>
                        <a:t> Acid, Aroma, </a:t>
                      </a:r>
                      <a:r>
                        <a:rPr lang="it-IT" sz="900" baseline="0" dirty="0" err="1" smtClean="0"/>
                        <a:t>Poloxamer</a:t>
                      </a:r>
                      <a:r>
                        <a:rPr lang="it-IT" sz="900" baseline="0" dirty="0" smtClean="0"/>
                        <a:t> 407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Metabisulfit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Citrate</a:t>
                      </a:r>
                      <a:r>
                        <a:rPr lang="it-IT" sz="900" baseline="0" dirty="0" smtClean="0"/>
                        <a:t>, CI 42090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2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Dentosan</a:t>
                      </a:r>
                      <a:r>
                        <a:rPr lang="it-IT" sz="1300" dirty="0" smtClean="0"/>
                        <a:t> Collutorio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300" dirty="0" smtClean="0"/>
                        <a:t>0.2% </a:t>
                      </a:r>
                      <a:r>
                        <a:rPr lang="it-IT" sz="1300" dirty="0" err="1" smtClean="0"/>
                        <a:t>Chlorhexidine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digluconate</a:t>
                      </a:r>
                      <a:endParaRPr lang="it-IT" sz="13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rb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Malt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ene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Glyc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oloxamer</a:t>
                      </a:r>
                      <a:r>
                        <a:rPr lang="it-IT" sz="900" dirty="0" smtClean="0"/>
                        <a:t> 407, Aroma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Sacchari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Citric</a:t>
                      </a:r>
                      <a:r>
                        <a:rPr lang="it-IT" sz="900" dirty="0" smtClean="0"/>
                        <a:t> Acid, CI 47005, CI 42015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3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Meridol</a:t>
                      </a:r>
                      <a:r>
                        <a:rPr lang="it-IT" sz="1300" dirty="0" smtClean="0"/>
                        <a:t> Collutorio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300" dirty="0" smtClean="0"/>
                        <a:t>0.2% </a:t>
                      </a:r>
                      <a:r>
                        <a:rPr lang="it-IT" sz="1300" dirty="0" err="1" smtClean="0"/>
                        <a:t>Chlorhexidine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digluconate</a:t>
                      </a:r>
                      <a:endParaRPr lang="it-IT" sz="13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Glycerine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rbitol</a:t>
                      </a:r>
                      <a:r>
                        <a:rPr lang="it-IT" sz="900" dirty="0" smtClean="0"/>
                        <a:t>, PEG-40 </a:t>
                      </a:r>
                      <a:r>
                        <a:rPr lang="it-IT" sz="900" dirty="0" err="1" smtClean="0"/>
                        <a:t>Hydrogenated</a:t>
                      </a:r>
                      <a:r>
                        <a:rPr lang="it-IT" sz="900" dirty="0" smtClean="0"/>
                        <a:t> Castor </a:t>
                      </a:r>
                      <a:r>
                        <a:rPr lang="it-IT" sz="900" dirty="0" err="1" smtClean="0"/>
                        <a:t>Oil</a:t>
                      </a:r>
                      <a:r>
                        <a:rPr lang="it-IT" sz="900" dirty="0" smtClean="0"/>
                        <a:t>, Aroma, </a:t>
                      </a:r>
                      <a:r>
                        <a:rPr lang="it-IT" sz="900" dirty="0" err="1" smtClean="0"/>
                        <a:t>Citric</a:t>
                      </a:r>
                      <a:r>
                        <a:rPr lang="it-IT" sz="900" dirty="0" smtClean="0"/>
                        <a:t> Acid, CI 42051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4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Elmex</a:t>
                      </a:r>
                      <a:r>
                        <a:rPr lang="it-IT" sz="1300" dirty="0" smtClean="0"/>
                        <a:t> Sensitive Professional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Olaflur</a:t>
                      </a:r>
                      <a:r>
                        <a:rPr lang="it-IT" sz="1300" dirty="0" smtClean="0"/>
                        <a:t> (125 </a:t>
                      </a:r>
                      <a:r>
                        <a:rPr lang="it-IT" sz="1300" dirty="0" err="1" smtClean="0"/>
                        <a:t>ppM</a:t>
                      </a:r>
                      <a:r>
                        <a:rPr lang="it-IT" sz="1300" dirty="0" smtClean="0"/>
                        <a:t> F</a:t>
                      </a:r>
                      <a:r>
                        <a:rPr lang="it-IT" sz="1300" baseline="30000" dirty="0" smtClean="0"/>
                        <a:t>-</a:t>
                      </a:r>
                      <a:r>
                        <a:rPr lang="it-IT" sz="1300" dirty="0" smtClean="0"/>
                        <a:t>)</a:t>
                      </a:r>
                    </a:p>
                    <a:p>
                      <a:r>
                        <a:rPr lang="it-IT" sz="1300" dirty="0" err="1" smtClean="0"/>
                        <a:t>Sod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Fluoride</a:t>
                      </a:r>
                      <a:r>
                        <a:rPr lang="it-IT" sz="1300" dirty="0" smtClean="0"/>
                        <a:t> (125 </a:t>
                      </a:r>
                      <a:r>
                        <a:rPr lang="it-IT" sz="1300" dirty="0" err="1" smtClean="0"/>
                        <a:t>ppM</a:t>
                      </a:r>
                      <a:r>
                        <a:rPr lang="it-IT" sz="1300" dirty="0" smtClean="0"/>
                        <a:t> F</a:t>
                      </a:r>
                      <a:r>
                        <a:rPr lang="it-IT" sz="1300" baseline="30000" dirty="0" smtClean="0"/>
                        <a:t>-</a:t>
                      </a:r>
                      <a:r>
                        <a:rPr lang="it-IT" sz="1300" dirty="0" smtClean="0"/>
                        <a:t>)</a:t>
                      </a:r>
                      <a:endParaRPr lang="it-IT" sz="13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Glyceri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rb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ene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Glyc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Di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Pyrophosphate</a:t>
                      </a:r>
                      <a:r>
                        <a:rPr lang="it-IT" sz="900" dirty="0" smtClean="0"/>
                        <a:t>, PEG-40 </a:t>
                      </a:r>
                      <a:r>
                        <a:rPr lang="it-IT" sz="900" dirty="0" err="1" smtClean="0"/>
                        <a:t>Hydrogenated</a:t>
                      </a:r>
                      <a:r>
                        <a:rPr lang="it-IT" sz="900" dirty="0" smtClean="0"/>
                        <a:t> Castor </a:t>
                      </a:r>
                      <a:r>
                        <a:rPr lang="it-IT" sz="900" dirty="0" err="1" smtClean="0"/>
                        <a:t>oil</a:t>
                      </a:r>
                      <a:r>
                        <a:rPr lang="it-IT" sz="900" dirty="0" smtClean="0"/>
                        <a:t>, PVM/MA </a:t>
                      </a:r>
                      <a:r>
                        <a:rPr lang="it-IT" sz="900" dirty="0" err="1" smtClean="0"/>
                        <a:t>Copolymer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Tetrapotass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Pyrophosphate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Levulinate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Anisate, Aroma, </a:t>
                      </a:r>
                      <a:r>
                        <a:rPr lang="it-IT" sz="900" dirty="0" err="1" smtClean="0"/>
                        <a:t>Potass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Hydroxide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Saccharine</a:t>
                      </a:r>
                      <a:r>
                        <a:rPr lang="it-IT" sz="900" dirty="0" smtClean="0"/>
                        <a:t>, CI 19140, CI 42051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5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Listerine</a:t>
                      </a:r>
                      <a:r>
                        <a:rPr lang="it-IT" sz="1300" dirty="0" smtClean="0"/>
                        <a:t> Total Care Zero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Eucalyptol</a:t>
                      </a:r>
                      <a:r>
                        <a:rPr lang="it-IT" sz="1300" dirty="0" smtClean="0"/>
                        <a:t>, </a:t>
                      </a:r>
                      <a:r>
                        <a:rPr lang="it-IT" sz="1300" dirty="0" err="1" smtClean="0"/>
                        <a:t>Thymol</a:t>
                      </a:r>
                      <a:r>
                        <a:rPr lang="it-IT" sz="1300" dirty="0" smtClean="0"/>
                        <a:t>, </a:t>
                      </a:r>
                      <a:r>
                        <a:rPr lang="it-IT" sz="1300" dirty="0" err="1" smtClean="0"/>
                        <a:t>Menthol</a:t>
                      </a:r>
                      <a:endParaRPr lang="it-IT" sz="1300" dirty="0" smtClean="0"/>
                    </a:p>
                    <a:p>
                      <a:r>
                        <a:rPr lang="it-IT" sz="1300" dirty="0" err="1" smtClean="0"/>
                        <a:t>Sod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Fluoride</a:t>
                      </a:r>
                      <a:r>
                        <a:rPr lang="it-IT" sz="1300" dirty="0" smtClean="0"/>
                        <a:t> (220 </a:t>
                      </a:r>
                      <a:r>
                        <a:rPr lang="it-IT" sz="1300" dirty="0" err="1" smtClean="0"/>
                        <a:t>ppM</a:t>
                      </a:r>
                      <a:r>
                        <a:rPr lang="it-IT" sz="1300" dirty="0" smtClean="0"/>
                        <a:t> F</a:t>
                      </a:r>
                      <a:r>
                        <a:rPr lang="it-IT" sz="1300" baseline="30000" dirty="0" smtClean="0"/>
                        <a:t>-</a:t>
                      </a:r>
                      <a:r>
                        <a:rPr lang="it-IT" sz="1300" dirty="0" smtClean="0"/>
                        <a:t>)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rb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ene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Glyc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oloxamer</a:t>
                      </a:r>
                      <a:r>
                        <a:rPr lang="it-IT" sz="900" dirty="0" smtClean="0"/>
                        <a:t> 407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Lauryl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Sulphate</a:t>
                      </a:r>
                      <a:r>
                        <a:rPr lang="it-IT" sz="900" dirty="0" smtClean="0"/>
                        <a:t>,</a:t>
                      </a:r>
                      <a:r>
                        <a:rPr lang="it-IT" sz="900" baseline="0" dirty="0" smtClean="0"/>
                        <a:t> Aroma, </a:t>
                      </a:r>
                      <a:r>
                        <a:rPr lang="it-IT" sz="900" baseline="0" dirty="0" err="1" smtClean="0"/>
                        <a:t>Zinc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Chlorid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Benzoic</a:t>
                      </a:r>
                      <a:r>
                        <a:rPr lang="it-IT" sz="900" baseline="0" dirty="0" smtClean="0"/>
                        <a:t> Acid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Benzoat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Methyl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Salicylat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Saccharin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Sucralose</a:t>
                      </a:r>
                      <a:r>
                        <a:rPr lang="it-IT" sz="900" baseline="0" dirty="0" smtClean="0"/>
                        <a:t>, CI16035, CI42090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7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Parodontax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smtClean="0"/>
                        <a:t>0.06% </a:t>
                      </a:r>
                      <a:r>
                        <a:rPr lang="it-IT" sz="1300" dirty="0" err="1" smtClean="0"/>
                        <a:t>Chlorhexidine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digluconate</a:t>
                      </a:r>
                      <a:endParaRPr lang="it-IT" sz="1300" dirty="0" smtClean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300" dirty="0" err="1" smtClean="0"/>
                        <a:t>Sod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Fluoride</a:t>
                      </a:r>
                      <a:r>
                        <a:rPr lang="it-IT" sz="1300" dirty="0" smtClean="0"/>
                        <a:t> (250 </a:t>
                      </a:r>
                      <a:r>
                        <a:rPr lang="it-IT" sz="1300" dirty="0" err="1" smtClean="0"/>
                        <a:t>ppM</a:t>
                      </a:r>
                      <a:r>
                        <a:rPr lang="it-IT" sz="1300" dirty="0" smtClean="0"/>
                        <a:t> F</a:t>
                      </a:r>
                      <a:r>
                        <a:rPr lang="it-IT" sz="1300" baseline="30000" dirty="0" smtClean="0"/>
                        <a:t>-</a:t>
                      </a:r>
                      <a:r>
                        <a:rPr lang="it-IT" sz="1300" dirty="0" smtClean="0"/>
                        <a:t>)</a:t>
                      </a:r>
                      <a:endParaRPr lang="it-IT" sz="13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ene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Glycol</a:t>
                      </a:r>
                      <a:r>
                        <a:rPr lang="it-IT" sz="900" dirty="0" smtClean="0"/>
                        <a:t>,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Sorbitol</a:t>
                      </a:r>
                      <a:r>
                        <a:rPr lang="it-IT" sz="900" baseline="0" dirty="0" smtClean="0"/>
                        <a:t>, PEG-40 </a:t>
                      </a:r>
                      <a:r>
                        <a:rPr lang="it-IT" sz="900" baseline="0" dirty="0" err="1" smtClean="0"/>
                        <a:t>Hydrogenated</a:t>
                      </a:r>
                      <a:r>
                        <a:rPr lang="it-IT" sz="900" baseline="0" dirty="0" smtClean="0"/>
                        <a:t> Castor </a:t>
                      </a:r>
                      <a:r>
                        <a:rPr lang="it-IT" sz="900" baseline="0" dirty="0" err="1" smtClean="0"/>
                        <a:t>Oil</a:t>
                      </a:r>
                      <a:r>
                        <a:rPr lang="it-IT" sz="900" baseline="0" dirty="0" smtClean="0"/>
                        <a:t>, Aroma, </a:t>
                      </a:r>
                      <a:r>
                        <a:rPr lang="it-IT" sz="900" baseline="0" dirty="0" err="1" smtClean="0"/>
                        <a:t>Methylparaben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Propylparaben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Saccharin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Eugenol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8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Oral</a:t>
                      </a:r>
                      <a:r>
                        <a:rPr lang="it-IT" sz="1300" dirty="0" smtClean="0"/>
                        <a:t> B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smtClean="0"/>
                        <a:t>0.05% </a:t>
                      </a:r>
                      <a:r>
                        <a:rPr lang="it-IT" sz="1300" dirty="0" err="1" smtClean="0"/>
                        <a:t>Cetylpyridin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Chloride</a:t>
                      </a:r>
                      <a:endParaRPr lang="it-IT" sz="1300" dirty="0" smtClean="0"/>
                    </a:p>
                    <a:p>
                      <a:r>
                        <a:rPr lang="it-IT" sz="1300" dirty="0" smtClean="0"/>
                        <a:t>0.05% </a:t>
                      </a:r>
                      <a:r>
                        <a:rPr lang="it-IT" sz="1300" dirty="0" err="1" smtClean="0"/>
                        <a:t>Sod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Fluoride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Glyceri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olysorbate</a:t>
                      </a:r>
                      <a:r>
                        <a:rPr lang="it-IT" sz="900" dirty="0" smtClean="0"/>
                        <a:t> 20, Aroma, </a:t>
                      </a:r>
                      <a:r>
                        <a:rPr lang="it-IT" sz="900" dirty="0" err="1" smtClean="0"/>
                        <a:t>Methylparabe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Sacchari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dium</a:t>
                      </a:r>
                      <a:r>
                        <a:rPr lang="it-IT" sz="900" dirty="0" smtClean="0"/>
                        <a:t> </a:t>
                      </a:r>
                      <a:r>
                        <a:rPr lang="it-IT" sz="900" dirty="0" err="1" smtClean="0"/>
                        <a:t>Benzoate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Propylparaben</a:t>
                      </a:r>
                      <a:r>
                        <a:rPr lang="it-IT" sz="900" dirty="0" smtClean="0"/>
                        <a:t>, CI 42051, CI 47005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1400" b="1" dirty="0" smtClean="0"/>
                        <a:t>9</a:t>
                      </a:r>
                      <a:endPara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PlaKKontrol</a:t>
                      </a:r>
                      <a:r>
                        <a:rPr lang="it-IT" sz="1300" baseline="0" dirty="0" smtClean="0"/>
                        <a:t> Protezione Totale</a:t>
                      </a:r>
                      <a:endParaRPr lang="it-IT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1300" dirty="0" err="1" smtClean="0"/>
                        <a:t>Triclosan</a:t>
                      </a:r>
                      <a:endParaRPr lang="it-IT" sz="1300" dirty="0" smtClean="0"/>
                    </a:p>
                    <a:p>
                      <a:r>
                        <a:rPr lang="it-IT" sz="1300" dirty="0" err="1" smtClean="0"/>
                        <a:t>Sodium</a:t>
                      </a:r>
                      <a:r>
                        <a:rPr lang="it-IT" sz="1300" dirty="0" smtClean="0"/>
                        <a:t> </a:t>
                      </a:r>
                      <a:r>
                        <a:rPr lang="it-IT" sz="1300" dirty="0" err="1" smtClean="0"/>
                        <a:t>Fluoride</a:t>
                      </a:r>
                      <a:endParaRPr lang="it-IT" sz="13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it-IT" sz="900" dirty="0" err="1" smtClean="0"/>
                        <a:t>Aqua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Glycerin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Sorbito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Xylitol</a:t>
                      </a:r>
                      <a:r>
                        <a:rPr lang="it-IT" sz="900" dirty="0" smtClean="0"/>
                        <a:t>, PEG-40 </a:t>
                      </a:r>
                      <a:r>
                        <a:rPr lang="it-IT" sz="900" dirty="0" err="1" smtClean="0"/>
                        <a:t>Hydrogenated</a:t>
                      </a:r>
                      <a:r>
                        <a:rPr lang="it-IT" sz="900" dirty="0" smtClean="0"/>
                        <a:t> Castor </a:t>
                      </a:r>
                      <a:r>
                        <a:rPr lang="it-IT" sz="900" dirty="0" err="1" smtClean="0"/>
                        <a:t>Oil</a:t>
                      </a:r>
                      <a:r>
                        <a:rPr lang="it-IT" sz="900" dirty="0" smtClean="0"/>
                        <a:t>, </a:t>
                      </a:r>
                      <a:r>
                        <a:rPr lang="it-IT" sz="900" dirty="0" err="1" smtClean="0"/>
                        <a:t>Imidazolidinyl</a:t>
                      </a:r>
                      <a:r>
                        <a:rPr lang="it-IT" sz="900" dirty="0" smtClean="0"/>
                        <a:t> Urea, Aroma, Centella Asiatica </a:t>
                      </a:r>
                      <a:r>
                        <a:rPr lang="it-IT" sz="900" dirty="0" err="1" smtClean="0"/>
                        <a:t>Extract</a:t>
                      </a:r>
                      <a:r>
                        <a:rPr lang="it-IT" sz="900" dirty="0" smtClean="0"/>
                        <a:t>,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Propylene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Glycol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Methylparaben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Disod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Pyrophosphat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Tetrapotassium</a:t>
                      </a:r>
                      <a:r>
                        <a:rPr lang="it-IT" sz="900" baseline="0" dirty="0" smtClean="0"/>
                        <a:t> </a:t>
                      </a:r>
                      <a:r>
                        <a:rPr lang="it-IT" sz="900" baseline="0" dirty="0" err="1" smtClean="0"/>
                        <a:t>Pyrophosphate</a:t>
                      </a:r>
                      <a:r>
                        <a:rPr lang="it-IT" sz="900" baseline="0" dirty="0" smtClean="0"/>
                        <a:t>, </a:t>
                      </a:r>
                      <a:r>
                        <a:rPr lang="it-IT" sz="900" baseline="0" dirty="0" err="1" smtClean="0"/>
                        <a:t>Limonene</a:t>
                      </a:r>
                      <a:r>
                        <a:rPr lang="it-IT" sz="900" baseline="0" dirty="0" smtClean="0"/>
                        <a:t>, CI 42090, CI 19140</a:t>
                      </a:r>
                      <a:endPara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CasellaDiTesto 1"/>
          <p:cNvSpPr txBox="1"/>
          <p:nvPr/>
        </p:nvSpPr>
        <p:spPr>
          <a:xfrm>
            <a:off x="444616" y="6191075"/>
            <a:ext cx="2371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Supplementary</a:t>
            </a:r>
            <a:r>
              <a:rPr lang="it-IT" b="1" dirty="0" smtClean="0"/>
              <a:t> </a:t>
            </a:r>
            <a:r>
              <a:rPr lang="it-IT" b="1" dirty="0" err="1" smtClean="0"/>
              <a:t>Table</a:t>
            </a:r>
            <a:r>
              <a:rPr lang="it-IT" b="1" dirty="0" smtClean="0"/>
              <a:t> 1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41872114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336</Words>
  <Application>Microsoft Office PowerPoint</Application>
  <PresentationFormat>Presentazione su schermo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</dc:creator>
  <cp:lastModifiedBy>Andrea</cp:lastModifiedBy>
  <cp:revision>11</cp:revision>
  <cp:lastPrinted>2018-06-11T15:13:01Z</cp:lastPrinted>
  <dcterms:created xsi:type="dcterms:W3CDTF">2018-06-08T10:06:19Z</dcterms:created>
  <dcterms:modified xsi:type="dcterms:W3CDTF">2018-06-11T15:13:06Z</dcterms:modified>
</cp:coreProperties>
</file>